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480175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8DEC715-51F4-4F97-A991-B7FA43E54144}" v="1" dt="2021-11-25T11:59:15.0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241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openxmlformats.org/officeDocument/2006/relationships/customXml" Target="../customXml/item3.xml"/><Relationship Id="rId5" Type="http://schemas.openxmlformats.org/officeDocument/2006/relationships/theme" Target="theme/theme1.xml"/><Relationship Id="rId10" Type="http://schemas.openxmlformats.org/officeDocument/2006/relationships/customXml" Target="../customXml/item2.xml"/><Relationship Id="rId4" Type="http://schemas.openxmlformats.org/officeDocument/2006/relationships/viewProps" Target="viewProps.xml"/><Relationship Id="rId9" Type="http://schemas.openxmlformats.org/officeDocument/2006/relationships/customXml" Target="../customXml/item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enke Wevers | Mimetas" userId="c19e51fc-cae2-4d68-9620-9d8f1df2a2e3" providerId="ADAL" clId="{A8DEC715-51F4-4F97-A991-B7FA43E54144}"/>
    <pc:docChg chg="custSel modSld">
      <pc:chgData name="Nienke Wevers | Mimetas" userId="c19e51fc-cae2-4d68-9620-9d8f1df2a2e3" providerId="ADAL" clId="{A8DEC715-51F4-4F97-A991-B7FA43E54144}" dt="2021-11-25T11:59:18.128" v="2" actId="1076"/>
      <pc:docMkLst>
        <pc:docMk/>
      </pc:docMkLst>
      <pc:sldChg chg="addSp delSp modSp mod">
        <pc:chgData name="Nienke Wevers | Mimetas" userId="c19e51fc-cae2-4d68-9620-9d8f1df2a2e3" providerId="ADAL" clId="{A8DEC715-51F4-4F97-A991-B7FA43E54144}" dt="2021-11-25T11:59:18.128" v="2" actId="1076"/>
        <pc:sldMkLst>
          <pc:docMk/>
          <pc:sldMk cId="3806075838" sldId="256"/>
        </pc:sldMkLst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0" creationId="{36F03907-9095-410E-B996-3AE4D3FABAEB}"/>
          </ac:spMkLst>
        </pc:spChg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3" creationId="{204E729C-D02A-4A41-8F14-2440622A05C0}"/>
          </ac:spMkLst>
        </pc:spChg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4" creationId="{229E6967-9DB3-4ECB-856B-592855FDEDFE}"/>
          </ac:spMkLst>
        </pc:spChg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5" creationId="{502CECA1-F523-447D-BAEB-3A29CF47A016}"/>
          </ac:spMkLst>
        </pc:spChg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6" creationId="{6804F7B9-81D6-4A84-8997-B99D737730C3}"/>
          </ac:spMkLst>
        </pc:spChg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7" creationId="{290E26CF-3E3E-4C09-94C2-5D73146221A1}"/>
          </ac:spMkLst>
        </pc:spChg>
        <pc:spChg chg="mod">
          <ac:chgData name="Nienke Wevers | Mimetas" userId="c19e51fc-cae2-4d68-9620-9d8f1df2a2e3" providerId="ADAL" clId="{A8DEC715-51F4-4F97-A991-B7FA43E54144}" dt="2021-11-25T11:59:15.048" v="1"/>
          <ac:spMkLst>
            <pc:docMk/>
            <pc:sldMk cId="3806075838" sldId="256"/>
            <ac:spMk id="138" creationId="{5B59D649-28F0-4F02-AC12-00F3AF660E03}"/>
          </ac:spMkLst>
        </pc:spChg>
        <pc:grpChg chg="del">
          <ac:chgData name="Nienke Wevers | Mimetas" userId="c19e51fc-cae2-4d68-9620-9d8f1df2a2e3" providerId="ADAL" clId="{A8DEC715-51F4-4F97-A991-B7FA43E54144}" dt="2021-11-25T11:59:08.251" v="0" actId="478"/>
          <ac:grpSpMkLst>
            <pc:docMk/>
            <pc:sldMk cId="3806075838" sldId="256"/>
            <ac:grpSpMk id="114" creationId="{E5690E60-2AAE-4B98-87E3-B0D6C7723EEF}"/>
          </ac:grpSpMkLst>
        </pc:grpChg>
        <pc:grpChg chg="add mod">
          <ac:chgData name="Nienke Wevers | Mimetas" userId="c19e51fc-cae2-4d68-9620-9d8f1df2a2e3" providerId="ADAL" clId="{A8DEC715-51F4-4F97-A991-B7FA43E54144}" dt="2021-11-25T11:59:18.128" v="2" actId="1076"/>
          <ac:grpSpMkLst>
            <pc:docMk/>
            <pc:sldMk cId="3806075838" sldId="256"/>
            <ac:grpSpMk id="129" creationId="{43D270B1-6B4E-43AC-B181-A6BB3B288ACF}"/>
          </ac:grpSpMkLst>
        </pc:grpChg>
        <pc:picChg chg="mod">
          <ac:chgData name="Nienke Wevers | Mimetas" userId="c19e51fc-cae2-4d68-9620-9d8f1df2a2e3" providerId="ADAL" clId="{A8DEC715-51F4-4F97-A991-B7FA43E54144}" dt="2021-11-25T11:59:15.048" v="1"/>
          <ac:picMkLst>
            <pc:docMk/>
            <pc:sldMk cId="3806075838" sldId="256"/>
            <ac:picMk id="131" creationId="{7C549344-A976-4D84-9330-75825C551A97}"/>
          </ac:picMkLst>
        </pc:picChg>
        <pc:picChg chg="mod">
          <ac:chgData name="Nienke Wevers | Mimetas" userId="c19e51fc-cae2-4d68-9620-9d8f1df2a2e3" providerId="ADAL" clId="{A8DEC715-51F4-4F97-A991-B7FA43E54144}" dt="2021-11-25T11:59:15.048" v="1"/>
          <ac:picMkLst>
            <pc:docMk/>
            <pc:sldMk cId="3806075838" sldId="256"/>
            <ac:picMk id="132" creationId="{6B07E8A6-005E-4B33-8594-E480C83AFB54}"/>
          </ac:picMkLst>
        </pc:picChg>
        <pc:picChg chg="mod">
          <ac:chgData name="Nienke Wevers | Mimetas" userId="c19e51fc-cae2-4d68-9620-9d8f1df2a2e3" providerId="ADAL" clId="{A8DEC715-51F4-4F97-A991-B7FA43E54144}" dt="2021-11-25T11:59:15.048" v="1"/>
          <ac:picMkLst>
            <pc:docMk/>
            <pc:sldMk cId="3806075838" sldId="256"/>
            <ac:picMk id="139" creationId="{1B10F8B5-C932-4C9E-BDB2-8BE3136B59FC}"/>
          </ac:picMkLst>
        </pc:picChg>
        <pc:picChg chg="mod">
          <ac:chgData name="Nienke Wevers | Mimetas" userId="c19e51fc-cae2-4d68-9620-9d8f1df2a2e3" providerId="ADAL" clId="{A8DEC715-51F4-4F97-A991-B7FA43E54144}" dt="2021-11-25T11:59:15.048" v="1"/>
          <ac:picMkLst>
            <pc:docMk/>
            <pc:sldMk cId="3806075838" sldId="256"/>
            <ac:picMk id="140" creationId="{5CCC8E2A-BDDD-474D-AAF0-A99E8E11F407}"/>
          </ac:picMkLst>
        </pc:picChg>
        <pc:picChg chg="mod">
          <ac:chgData name="Nienke Wevers | Mimetas" userId="c19e51fc-cae2-4d68-9620-9d8f1df2a2e3" providerId="ADAL" clId="{A8DEC715-51F4-4F97-A991-B7FA43E54144}" dt="2021-11-25T11:59:15.048" v="1"/>
          <ac:picMkLst>
            <pc:docMk/>
            <pc:sldMk cId="3806075838" sldId="256"/>
            <ac:picMk id="141" creationId="{A2EC26B7-18BD-4439-B4BA-F647FE583C71}"/>
          </ac:picMkLst>
        </pc:picChg>
        <pc:picChg chg="mod">
          <ac:chgData name="Nienke Wevers | Mimetas" userId="c19e51fc-cae2-4d68-9620-9d8f1df2a2e3" providerId="ADAL" clId="{A8DEC715-51F4-4F97-A991-B7FA43E54144}" dt="2021-11-25T11:59:15.048" v="1"/>
          <ac:picMkLst>
            <pc:docMk/>
            <pc:sldMk cId="3806075838" sldId="256"/>
            <ac:picMk id="142" creationId="{629686BA-73DD-4EE3-B73B-E0EE66141C1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355149"/>
            <a:ext cx="5508149" cy="288280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349128"/>
            <a:ext cx="4860131" cy="1999179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428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324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40855"/>
            <a:ext cx="1397288" cy="70172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40855"/>
            <a:ext cx="4110861" cy="70172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240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551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064352"/>
            <a:ext cx="5589151" cy="3444416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541353"/>
            <a:ext cx="5589151" cy="181133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945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204273"/>
            <a:ext cx="2754074" cy="525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204273"/>
            <a:ext cx="2754074" cy="525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002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40856"/>
            <a:ext cx="5589151" cy="1600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029849"/>
            <a:ext cx="2741417" cy="99479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024646"/>
            <a:ext cx="2741417" cy="44487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029849"/>
            <a:ext cx="2754918" cy="99479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024646"/>
            <a:ext cx="2754918" cy="44487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151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687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95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2027"/>
            <a:ext cx="2090025" cy="193209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92226"/>
            <a:ext cx="3280589" cy="5884451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484120"/>
            <a:ext cx="2090025" cy="460214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339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2027"/>
            <a:ext cx="2090025" cy="193209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92226"/>
            <a:ext cx="3280589" cy="5884451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484120"/>
            <a:ext cx="2090025" cy="460214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6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40856"/>
            <a:ext cx="5589151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204273"/>
            <a:ext cx="5589151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674706"/>
            <a:ext cx="145803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EE75D-E68A-4017-B333-E3461C0B03A9}" type="datetimeFigureOut">
              <a:rPr lang="en-US" smtClean="0"/>
              <a:t>11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674706"/>
            <a:ext cx="218705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674706"/>
            <a:ext cx="145803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89DDA-5695-4F96-8FDF-516BCD7B2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6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9" name="Group 128">
            <a:extLst>
              <a:ext uri="{FF2B5EF4-FFF2-40B4-BE49-F238E27FC236}">
                <a16:creationId xmlns:a16="http://schemas.microsoft.com/office/drawing/2014/main" id="{43D270B1-6B4E-43AC-B181-A6BB3B288ACF}"/>
              </a:ext>
            </a:extLst>
          </p:cNvPr>
          <p:cNvGrpSpPr/>
          <p:nvPr/>
        </p:nvGrpSpPr>
        <p:grpSpPr>
          <a:xfrm>
            <a:off x="238860" y="358804"/>
            <a:ext cx="6241315" cy="2978289"/>
            <a:chOff x="803632" y="885929"/>
            <a:chExt cx="6241315" cy="2978289"/>
          </a:xfrm>
        </p:grpSpPr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36F03907-9095-410E-B996-3AE4D3FABAEB}"/>
                </a:ext>
              </a:extLst>
            </p:cNvPr>
            <p:cNvSpPr txBox="1"/>
            <p:nvPr/>
          </p:nvSpPr>
          <p:spPr>
            <a:xfrm>
              <a:off x="2710575" y="885929"/>
              <a:ext cx="2986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4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1" name="Picture 130" descr="A close up of a device&#10;&#10;Description automatically generated">
              <a:extLst>
                <a:ext uri="{FF2B5EF4-FFF2-40B4-BE49-F238E27FC236}">
                  <a16:creationId xmlns:a16="http://schemas.microsoft.com/office/drawing/2014/main" id="{7C549344-A976-4D84-9330-75825C551A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389" b="9005"/>
            <a:stretch/>
          </p:blipFill>
          <p:spPr>
            <a:xfrm>
              <a:off x="1092373" y="1246325"/>
              <a:ext cx="1584923" cy="10298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2" name="Picture 131" descr="A close up of a device&#10;&#10;Description automatically generated">
              <a:extLst>
                <a:ext uri="{FF2B5EF4-FFF2-40B4-BE49-F238E27FC236}">
                  <a16:creationId xmlns:a16="http://schemas.microsoft.com/office/drawing/2014/main" id="{6B07E8A6-005E-4B33-8594-E480C83AFB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29" t="43418" r="56235" b="42575"/>
            <a:stretch/>
          </p:blipFill>
          <p:spPr>
            <a:xfrm>
              <a:off x="1092372" y="2500636"/>
              <a:ext cx="1584000" cy="12474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204E729C-D02A-4A41-8F14-2440622A05C0}"/>
                </a:ext>
              </a:extLst>
            </p:cNvPr>
            <p:cNvSpPr txBox="1"/>
            <p:nvPr/>
          </p:nvSpPr>
          <p:spPr>
            <a:xfrm>
              <a:off x="803632" y="911096"/>
              <a:ext cx="3688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4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229E6967-9DB3-4ECB-856B-592855FDEDFE}"/>
                </a:ext>
              </a:extLst>
            </p:cNvPr>
            <p:cNvSpPr txBox="1"/>
            <p:nvPr/>
          </p:nvSpPr>
          <p:spPr>
            <a:xfrm>
              <a:off x="803632" y="2415442"/>
              <a:ext cx="3688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4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502CECA1-F523-447D-BAEB-3A29CF47A016}"/>
                </a:ext>
              </a:extLst>
            </p:cNvPr>
            <p:cNvSpPr txBox="1"/>
            <p:nvPr/>
          </p:nvSpPr>
          <p:spPr>
            <a:xfrm>
              <a:off x="2922987" y="1015238"/>
              <a:ext cx="10847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>
                  <a:latin typeface="Arial" panose="020B0604020202020204" pitchFamily="34" charset="0"/>
                  <a:cs typeface="Arial" panose="020B0604020202020204" pitchFamily="34" charset="0"/>
                </a:rPr>
                <a:t>1. Empty chip</a:t>
              </a:r>
              <a:endParaRPr 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804F7B9-81D6-4A84-8997-B99D737730C3}"/>
                </a:ext>
              </a:extLst>
            </p:cNvPr>
            <p:cNvSpPr txBox="1"/>
            <p:nvPr/>
          </p:nvSpPr>
          <p:spPr>
            <a:xfrm>
              <a:off x="4946127" y="1015238"/>
              <a:ext cx="20988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>
                  <a:latin typeface="Arial" panose="020B0604020202020204" pitchFamily="34" charset="0"/>
                  <a:cs typeface="Arial" panose="020B0604020202020204" pitchFamily="34" charset="0"/>
                </a:rPr>
                <a:t>2. ECM gel loading</a:t>
              </a:r>
              <a:endParaRPr 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290E26CF-3E3E-4C09-94C2-5D73146221A1}"/>
                </a:ext>
              </a:extLst>
            </p:cNvPr>
            <p:cNvSpPr txBox="1"/>
            <p:nvPr/>
          </p:nvSpPr>
          <p:spPr>
            <a:xfrm>
              <a:off x="2902824" y="2486517"/>
              <a:ext cx="31423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>
                  <a:latin typeface="Arial" panose="020B0604020202020204" pitchFamily="34" charset="0"/>
                  <a:cs typeface="Arial" panose="020B0604020202020204" pitchFamily="34" charset="0"/>
                </a:rPr>
                <a:t>3. Addition of astrocytes and neurons</a:t>
              </a:r>
              <a:endParaRPr 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5B59D649-28F0-4F02-AC12-00F3AF660E03}"/>
                </a:ext>
              </a:extLst>
            </p:cNvPr>
            <p:cNvSpPr txBox="1"/>
            <p:nvPr/>
          </p:nvSpPr>
          <p:spPr>
            <a:xfrm>
              <a:off x="4995491" y="2486517"/>
              <a:ext cx="19574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>
                  <a:latin typeface="Arial" panose="020B0604020202020204" pitchFamily="34" charset="0"/>
                  <a:cs typeface="Arial" panose="020B0604020202020204" pitchFamily="34" charset="0"/>
                </a:rPr>
                <a:t>4. Addition of brain endothelial cells</a:t>
              </a:r>
              <a:endParaRPr 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9" name="Picture 138" descr="A picture containing text, businesscard&#10;&#10;Description automatically generated">
              <a:extLst>
                <a:ext uri="{FF2B5EF4-FFF2-40B4-BE49-F238E27FC236}">
                  <a16:creationId xmlns:a16="http://schemas.microsoft.com/office/drawing/2014/main" id="{1B10F8B5-C932-4C9E-BDB2-8BE3136B59F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94355" y="2676218"/>
              <a:ext cx="2058603" cy="1188000"/>
            </a:xfrm>
            <a:prstGeom prst="rect">
              <a:avLst/>
            </a:prstGeom>
          </p:spPr>
        </p:pic>
        <p:pic>
          <p:nvPicPr>
            <p:cNvPr id="140" name="Picture 139" descr="A picture containing text, businesscard&#10;&#10;Description automatically generated">
              <a:extLst>
                <a:ext uri="{FF2B5EF4-FFF2-40B4-BE49-F238E27FC236}">
                  <a16:creationId xmlns:a16="http://schemas.microsoft.com/office/drawing/2014/main" id="{5CCC8E2A-BDDD-474D-AAF0-A99E8E11F4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02568" y="2676218"/>
              <a:ext cx="2060329" cy="1188000"/>
            </a:xfrm>
            <a:prstGeom prst="rect">
              <a:avLst/>
            </a:prstGeom>
          </p:spPr>
        </p:pic>
        <p:pic>
          <p:nvPicPr>
            <p:cNvPr id="141" name="Picture 140" descr="A picture containing text, businesscard&#10;&#10;Description automatically generated">
              <a:extLst>
                <a:ext uri="{FF2B5EF4-FFF2-40B4-BE49-F238E27FC236}">
                  <a16:creationId xmlns:a16="http://schemas.microsoft.com/office/drawing/2014/main" id="{A2EC26B7-18BD-4439-B4BA-F647FE583C7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94355" y="1178049"/>
              <a:ext cx="2058603" cy="1188000"/>
            </a:xfrm>
            <a:prstGeom prst="rect">
              <a:avLst/>
            </a:prstGeom>
          </p:spPr>
        </p:pic>
        <p:pic>
          <p:nvPicPr>
            <p:cNvPr id="142" name="Picture 141" descr="Icon&#10;&#10;Description automatically generated">
              <a:extLst>
                <a:ext uri="{FF2B5EF4-FFF2-40B4-BE49-F238E27FC236}">
                  <a16:creationId xmlns:a16="http://schemas.microsoft.com/office/drawing/2014/main" id="{629686BA-73DD-4EE3-B73B-E0EE66141C1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02568" y="1178049"/>
              <a:ext cx="2058603" cy="1188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06075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A3749E8B7DECE4190E99A6B653AC068" ma:contentTypeVersion="14" ma:contentTypeDescription="Create a new document." ma:contentTypeScope="" ma:versionID="a4ab55f3567cb47c287f33f0f0038e32">
  <xsd:schema xmlns:xsd="http://www.w3.org/2001/XMLSchema" xmlns:xs="http://www.w3.org/2001/XMLSchema" xmlns:p="http://schemas.microsoft.com/office/2006/metadata/properties" xmlns:ns2="d2ffc157-d434-44de-abac-f817f22f6f25" xmlns:ns3="a2236ccf-a90d-4100-b08b-13936447d0cc" targetNamespace="http://schemas.microsoft.com/office/2006/metadata/properties" ma:root="true" ma:fieldsID="07498b950f40dc109f07fbe3d0f6814e" ns2:_="" ns3:_="">
    <xsd:import namespace="d2ffc157-d434-44de-abac-f817f22f6f25"/>
    <xsd:import namespace="a2236ccf-a90d-4100-b08b-13936447d0c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Location" minOccurs="0"/>
                <xsd:element ref="ns3:SharedWithUsers" minOccurs="0"/>
                <xsd:element ref="ns3:SharedWithDetail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Size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2ffc157-d434-44de-abac-f817f22f6f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Size" ma:index="20" nillable="true" ma:displayName="Size" ma:format="Dropdown" ma:internalName="Size" ma:percentage="FALSE">
      <xsd:simpleType>
        <xsd:restriction base="dms:Number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236ccf-a90d-4100-b08b-13936447d0cc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ize xmlns="d2ffc157-d434-44de-abac-f817f22f6f25" xsi:nil="true"/>
  </documentManagement>
</p:properties>
</file>

<file path=customXml/itemProps1.xml><?xml version="1.0" encoding="utf-8"?>
<ds:datastoreItem xmlns:ds="http://schemas.openxmlformats.org/officeDocument/2006/customXml" ds:itemID="{88BA958C-E034-420D-B1A8-2E59CC96E030}"/>
</file>

<file path=customXml/itemProps2.xml><?xml version="1.0" encoding="utf-8"?>
<ds:datastoreItem xmlns:ds="http://schemas.openxmlformats.org/officeDocument/2006/customXml" ds:itemID="{ED366C16-6F85-4C91-9345-B9186DE9FAF5}"/>
</file>

<file path=customXml/itemProps3.xml><?xml version="1.0" encoding="utf-8"?>
<ds:datastoreItem xmlns:ds="http://schemas.openxmlformats.org/officeDocument/2006/customXml" ds:itemID="{E60DEF89-7532-4B17-9AD7-969EB5A021C1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6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enke Wevers | Mimetas</dc:creator>
  <cp:lastModifiedBy>Nienke Wevers | Mimetas</cp:lastModifiedBy>
  <cp:revision>4</cp:revision>
  <dcterms:created xsi:type="dcterms:W3CDTF">2021-11-25T11:54:02Z</dcterms:created>
  <dcterms:modified xsi:type="dcterms:W3CDTF">2021-11-25T11:59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A3749E8B7DECE4190E99A6B653AC068</vt:lpwstr>
  </property>
</Properties>
</file>